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82" r:id="rId2"/>
    <p:sldId id="281" r:id="rId3"/>
    <p:sldId id="257" r:id="rId4"/>
    <p:sldId id="269" r:id="rId5"/>
    <p:sldId id="283" r:id="rId6"/>
    <p:sldId id="285" r:id="rId7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D6D6D6"/>
    <a:srgbClr val="F4FFA4"/>
    <a:srgbClr val="FFE4E6"/>
    <a:srgbClr val="FFFF66"/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355"/>
    <p:restoredTop sz="96208"/>
  </p:normalViewPr>
  <p:slideViewPr>
    <p:cSldViewPr snapToGrid="0" snapToObjects="1">
      <p:cViewPr varScale="1">
        <p:scale>
          <a:sx n="119" d="100"/>
          <a:sy n="119" d="100"/>
        </p:scale>
        <p:origin x="93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 snapToObjects="1">
      <p:cViewPr varScale="1">
        <p:scale>
          <a:sx n="94" d="100"/>
          <a:sy n="94" d="100"/>
        </p:scale>
        <p:origin x="3752" y="1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9664C-5BFB-E94F-80DD-98B863231FE7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910E01-B6ED-924F-B130-CDF0835877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321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910E01-B6ED-924F-B130-CDF083587737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6824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910E01-B6ED-924F-B130-CDF083587737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7375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849BE5-B4BA-0B45-92F9-C78134C958FE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7168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7952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8702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375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651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267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967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108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337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0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2450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9833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5EE0A-22D5-D64E-AF2C-318992981CB9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689A7-7832-1B40-9D0F-71EDEC6EC1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5519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5F31108-C8A3-FB4A-849B-5C24F5AB7D17}"/>
              </a:ext>
            </a:extLst>
          </p:cNvPr>
          <p:cNvSpPr txBox="1"/>
          <p:nvPr/>
        </p:nvSpPr>
        <p:spPr>
          <a:xfrm>
            <a:off x="702610" y="2743654"/>
            <a:ext cx="3158237" cy="22159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ctr">
              <a:lnSpc>
                <a:spcPct val="150000"/>
              </a:lnSpc>
            </a:pP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out shape, size or design?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out inhaler operation and procedure?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out actual feeling of being able to inhale?</a:t>
            </a:r>
          </a:p>
          <a:p>
            <a:pPr fontAlgn="ctr">
              <a:lnSpc>
                <a:spcPct val="150000"/>
              </a:lnSpc>
            </a:pP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out actual effect?</a:t>
            </a:r>
          </a:p>
          <a:p>
            <a:pPr fontAlgn="ctr">
              <a:lnSpc>
                <a:spcPct val="150000"/>
              </a:lnSpc>
            </a:pP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out side effects?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verall evaluation</a:t>
            </a:r>
          </a:p>
          <a:p>
            <a:pPr fontAlgn="ctr">
              <a:lnSpc>
                <a:spcPct val="150000"/>
              </a:lnSpc>
            </a:pPr>
            <a:r>
              <a:rPr lang="en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Which would you like to use from now?</a:t>
            </a:r>
            <a:endParaRPr lang="en-US" altLang="ja-JP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4022326-60F8-8F40-8203-A7F6DF60439B}"/>
              </a:ext>
            </a:extLst>
          </p:cNvPr>
          <p:cNvSpPr txBox="1"/>
          <p:nvPr/>
        </p:nvSpPr>
        <p:spPr>
          <a:xfrm>
            <a:off x="842310" y="1298068"/>
            <a:ext cx="278634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nter the ranking in parentheses "(  )".</a:t>
            </a:r>
            <a:b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You don't have to set the order. </a:t>
            </a:r>
          </a:p>
          <a:p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lease refer to the entry examples.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BAF1F5E-5FD6-354F-8C0F-3F1C646E077F}"/>
              </a:ext>
            </a:extLst>
          </p:cNvPr>
          <p:cNvSpPr txBox="1"/>
          <p:nvPr/>
        </p:nvSpPr>
        <p:spPr>
          <a:xfrm>
            <a:off x="4641100" y="2533750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anking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DCAF157-CD76-3F4C-8F8C-C47D903FC260}"/>
              </a:ext>
            </a:extLst>
          </p:cNvPr>
          <p:cNvSpPr txBox="1"/>
          <p:nvPr/>
        </p:nvSpPr>
        <p:spPr>
          <a:xfrm>
            <a:off x="842310" y="5208859"/>
            <a:ext cx="4886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f you have some reasons, please feel free to write in the blank below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6BD019C2-412B-9748-96C8-99C36840FC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8969" y="1603024"/>
            <a:ext cx="500462" cy="68275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92CB374-F1D9-B546-83C5-C7ECD40134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4491" y="1293492"/>
            <a:ext cx="423796" cy="98970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FB1FCC70-E3B8-C94E-A113-13AA4E0E6F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15813" y="1603024"/>
            <a:ext cx="539217" cy="68275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C9315F9-5193-9A4C-AC20-2B8071D9CE97}"/>
              </a:ext>
            </a:extLst>
          </p:cNvPr>
          <p:cNvSpPr txBox="1"/>
          <p:nvPr/>
        </p:nvSpPr>
        <p:spPr>
          <a:xfrm>
            <a:off x="3865347" y="2743654"/>
            <a:ext cx="2699778" cy="22159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           )         (           )        (        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           )         (           )        (        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           )         (           )        (        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           )         (           )        (        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           )         (           )        (           ) </a:t>
            </a:r>
          </a:p>
          <a:p>
            <a:pPr fontAlgn="ctr">
              <a:lnSpc>
                <a:spcPct val="150000"/>
              </a:lnSpc>
            </a:pPr>
            <a:endParaRPr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           )         (           )        (        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           )         (           )        (           ) 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FF83800-4113-8141-AD4F-A80F4142C36F}"/>
              </a:ext>
            </a:extLst>
          </p:cNvPr>
          <p:cNvSpPr txBox="1"/>
          <p:nvPr/>
        </p:nvSpPr>
        <p:spPr>
          <a:xfrm>
            <a:off x="3800813" y="2268835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Ultibro</a:t>
            </a:r>
            <a:r>
              <a:rPr lang="en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endParaRPr kumimoji="1" lang="ja-JP" altLang="en-US" sz="140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1ABE5EE-59C3-EE42-BACB-7B7FEFD81FB7}"/>
              </a:ext>
            </a:extLst>
          </p:cNvPr>
          <p:cNvSpPr txBox="1"/>
          <p:nvPr/>
        </p:nvSpPr>
        <p:spPr>
          <a:xfrm>
            <a:off x="4734442" y="2268835"/>
            <a:ext cx="7505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noro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endParaRPr kumimoji="1" lang="ja-JP" altLang="en-US" sz="140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7AD6299-D6C9-4C46-8E91-590E6F5FAD66}"/>
              </a:ext>
            </a:extLst>
          </p:cNvPr>
          <p:cNvSpPr txBox="1"/>
          <p:nvPr/>
        </p:nvSpPr>
        <p:spPr>
          <a:xfrm>
            <a:off x="5500160" y="2268835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piolto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endParaRPr kumimoji="1" lang="ja-JP" altLang="en-US" sz="140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E8EC1F16-85E7-0A4F-80F0-38CB874D6B23}"/>
              </a:ext>
            </a:extLst>
          </p:cNvPr>
          <p:cNvCxnSpPr/>
          <p:nvPr/>
        </p:nvCxnSpPr>
        <p:spPr>
          <a:xfrm>
            <a:off x="1163445" y="4890437"/>
            <a:ext cx="0" cy="34995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546DB19-93E4-224C-9C9F-40736F1DAAA4}"/>
              </a:ext>
            </a:extLst>
          </p:cNvPr>
          <p:cNvSpPr/>
          <p:nvPr/>
        </p:nvSpPr>
        <p:spPr>
          <a:xfrm>
            <a:off x="1015101" y="5538135"/>
            <a:ext cx="4999690" cy="435549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E327E20-272D-6644-898B-13B0C429A410}"/>
              </a:ext>
            </a:extLst>
          </p:cNvPr>
          <p:cNvSpPr txBox="1"/>
          <p:nvPr/>
        </p:nvSpPr>
        <p:spPr>
          <a:xfrm>
            <a:off x="6620575" y="3153717"/>
            <a:ext cx="1495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Entry example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AB2DCDF2-5B18-584D-B794-7E1C74F32559}"/>
              </a:ext>
            </a:extLst>
          </p:cNvPr>
          <p:cNvSpPr/>
          <p:nvPr/>
        </p:nvSpPr>
        <p:spPr>
          <a:xfrm>
            <a:off x="6489463" y="3414989"/>
            <a:ext cx="2019836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>
              <a:lnSpc>
                <a:spcPct val="150000"/>
              </a:lnSpc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   1st    )   (   2nd   )   (   3rd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   1st    )   (    1st   )   (   1st 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   1st    )   (    1st   )   (   2nd   ) </a:t>
            </a:r>
          </a:p>
          <a:p>
            <a:pPr fontAlgn="ctr">
              <a:lnSpc>
                <a:spcPct val="150000"/>
              </a:lnSpc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   1st    )   (   2nd   )   (   2nd   ) 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D6B90CA9-E7F4-DD40-90E0-544C01E9B4F6}"/>
              </a:ext>
            </a:extLst>
          </p:cNvPr>
          <p:cNvSpPr/>
          <p:nvPr/>
        </p:nvSpPr>
        <p:spPr>
          <a:xfrm>
            <a:off x="6502751" y="3153717"/>
            <a:ext cx="1928805" cy="1411982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AD5E5B3-6D70-1C49-9C67-CC3A2124375D}"/>
              </a:ext>
            </a:extLst>
          </p:cNvPr>
          <p:cNvSpPr txBox="1"/>
          <p:nvPr/>
        </p:nvSpPr>
        <p:spPr>
          <a:xfrm>
            <a:off x="475579" y="543274"/>
            <a:ext cx="832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1.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nd of the study comparative questionnaire concerning all three medications</a:t>
            </a:r>
            <a:endParaRPr lang="ja-JP" altLang="ja-JP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480F68C-55AA-884B-B3EA-C6C8CE1D4B22}"/>
              </a:ext>
            </a:extLst>
          </p:cNvPr>
          <p:cNvSpPr txBox="1"/>
          <p:nvPr/>
        </p:nvSpPr>
        <p:spPr>
          <a:xfrm>
            <a:off x="1263460" y="4166373"/>
            <a:ext cx="29931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00" dirty="0"/>
              <a:t>Fewer side effects or no side effects are ranked first</a:t>
            </a:r>
            <a:r>
              <a:rPr lang="ja-JP" altLang="ja-JP" sz="1000"/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58722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46D7CCA-CC0D-3743-94BB-87872B34ED84}"/>
              </a:ext>
            </a:extLst>
          </p:cNvPr>
          <p:cNvSpPr txBox="1"/>
          <p:nvPr/>
        </p:nvSpPr>
        <p:spPr>
          <a:xfrm>
            <a:off x="1202431" y="1228651"/>
            <a:ext cx="3278462" cy="49167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ide effect; Hoarseness</a:t>
            </a: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②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iscomfort or irritation of the throat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③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ide effect; Cough immediately after inhalation</a:t>
            </a: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④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ftertaste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⑤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ide effect; Headache </a:t>
            </a: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⑥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alpitation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⑦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remor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⑧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Eye pain,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leariness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⑨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Thirst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⑩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onstipation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⑪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ide effect; Difficulty of urination</a:t>
            </a:r>
          </a:p>
          <a:p>
            <a:pPr fontAlgn="ctr">
              <a:lnSpc>
                <a:spcPct val="150000"/>
              </a:lnSpc>
            </a:pPr>
            <a:endParaRPr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⑫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bout shape, size or design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⑬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bout inhaler operation and procedure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⑭ About actual feeling of being able to inhale</a:t>
            </a: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⑮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bout actual effect</a:t>
            </a: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⑯ Overall evaluation</a:t>
            </a:r>
          </a:p>
          <a:p>
            <a:pPr fontAlgn="ctr">
              <a:lnSpc>
                <a:spcPct val="150000"/>
              </a:lnSpc>
            </a:pPr>
            <a:endParaRPr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fontAlgn="ctr"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Visual Analog Scale (cm on the line of 10 cm)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7917638-F804-2A43-B3AD-97E9D1D9835D}"/>
              </a:ext>
            </a:extLst>
          </p:cNvPr>
          <p:cNvSpPr txBox="1"/>
          <p:nvPr/>
        </p:nvSpPr>
        <p:spPr>
          <a:xfrm>
            <a:off x="1866477" y="922765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Query item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D11DD94-1BB7-FE45-8440-F9B5F2A3D6AE}"/>
              </a:ext>
            </a:extLst>
          </p:cNvPr>
          <p:cNvSpPr txBox="1"/>
          <p:nvPr/>
        </p:nvSpPr>
        <p:spPr>
          <a:xfrm>
            <a:off x="4405145" y="1222066"/>
            <a:ext cx="3641574" cy="4631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/  Light  / 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retty much  / 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trong  / 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Never  /  Light  /  Pretty much  /  Strong  /  Intolerable )</a:t>
            </a:r>
          </a:p>
          <a:p>
            <a:pPr>
              <a:lnSpc>
                <a:spcPct val="150000"/>
              </a:lnSpc>
            </a:pPr>
            <a:endParaRPr kumimoji="1"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Very good / Good / Can't say either / Bad  /  Very bad )</a:t>
            </a:r>
          </a:p>
          <a:p>
            <a:pPr>
              <a:lnSpc>
                <a:spcPct val="150000"/>
              </a:lnSpc>
            </a:pP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Very good / Good / Can't say either / Bad  /  Very bad )</a:t>
            </a:r>
          </a:p>
          <a:p>
            <a:pPr>
              <a:lnSpc>
                <a:spcPct val="150000"/>
              </a:lnSpc>
            </a:pP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Very good / Good / Can't say either / Bad  /  Very bad )</a:t>
            </a:r>
          </a:p>
          <a:p>
            <a:pPr>
              <a:lnSpc>
                <a:spcPct val="150000"/>
              </a:lnSpc>
            </a:pP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Very good / Good / Can't say either / Bad  /  Very bad )</a:t>
            </a:r>
          </a:p>
          <a:p>
            <a:pPr>
              <a:lnSpc>
                <a:spcPct val="150000"/>
              </a:lnSpc>
            </a:pP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 Very good / Good / Can't say either / Bad  /  Very bad )</a:t>
            </a:r>
          </a:p>
          <a:p>
            <a:pPr>
              <a:lnSpc>
                <a:spcPct val="150000"/>
              </a:lnSpc>
            </a:pPr>
            <a:endParaRPr kumimoji="1"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1FD5457-C983-F642-B712-87432CCD9733}"/>
              </a:ext>
            </a:extLst>
          </p:cNvPr>
          <p:cNvSpPr txBox="1"/>
          <p:nvPr/>
        </p:nvSpPr>
        <p:spPr>
          <a:xfrm>
            <a:off x="4638905" y="959005"/>
            <a:ext cx="30011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0              1                 2                  3              4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7CDEDE8-D7E4-8C48-AAAE-D2C9083BC6E0}"/>
              </a:ext>
            </a:extLst>
          </p:cNvPr>
          <p:cNvSpPr txBox="1"/>
          <p:nvPr/>
        </p:nvSpPr>
        <p:spPr>
          <a:xfrm>
            <a:off x="5711696" y="69381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ore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743656BF-492D-3346-8734-14BDAEA2228D}"/>
              </a:ext>
            </a:extLst>
          </p:cNvPr>
          <p:cNvSpPr/>
          <p:nvPr/>
        </p:nvSpPr>
        <p:spPr>
          <a:xfrm>
            <a:off x="1182029" y="668013"/>
            <a:ext cx="6864690" cy="5580000"/>
          </a:xfrm>
          <a:prstGeom prst="rect">
            <a:avLst/>
          </a:prstGeom>
          <a:noFill/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FE9E59E6-03DB-6A4C-B4B7-0A6F57BD8AAA}"/>
              </a:ext>
            </a:extLst>
          </p:cNvPr>
          <p:cNvCxnSpPr>
            <a:cxnSpLocks/>
          </p:cNvCxnSpPr>
          <p:nvPr/>
        </p:nvCxnSpPr>
        <p:spPr>
          <a:xfrm>
            <a:off x="4406772" y="668013"/>
            <a:ext cx="0" cy="558000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64D49BBC-911A-304C-800E-C00D4F096322}"/>
              </a:ext>
            </a:extLst>
          </p:cNvPr>
          <p:cNvCxnSpPr>
            <a:cxnSpLocks/>
          </p:cNvCxnSpPr>
          <p:nvPr/>
        </p:nvCxnSpPr>
        <p:spPr>
          <a:xfrm>
            <a:off x="1182029" y="1199764"/>
            <a:ext cx="686469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663BC51-9225-A042-BA12-FC81B5DEA46A}"/>
              </a:ext>
            </a:extLst>
          </p:cNvPr>
          <p:cNvCxnSpPr>
            <a:cxnSpLocks/>
          </p:cNvCxnSpPr>
          <p:nvPr/>
        </p:nvCxnSpPr>
        <p:spPr>
          <a:xfrm>
            <a:off x="1182028" y="5734328"/>
            <a:ext cx="6864691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0BFDA51-B541-D340-A040-11D240E06745}"/>
              </a:ext>
            </a:extLst>
          </p:cNvPr>
          <p:cNvSpPr txBox="1"/>
          <p:nvPr/>
        </p:nvSpPr>
        <p:spPr>
          <a:xfrm>
            <a:off x="1182028" y="277464"/>
            <a:ext cx="6222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riginal questionnaire for completion after using each inhaler</a:t>
            </a:r>
            <a:r>
              <a:rPr lang="ja-JP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59044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33215" y="1387938"/>
            <a:ext cx="1510093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iotropium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SMI)</a:t>
            </a:r>
          </a:p>
          <a:p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lycopyrronium</a:t>
            </a:r>
            <a:endParaRPr lang="en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Umeclidinium</a:t>
            </a: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clidinium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837864" y="1387938"/>
            <a:ext cx="383438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776739" y="1390235"/>
            <a:ext cx="1559786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ndacaterol</a:t>
            </a: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ormoterol</a:t>
            </a: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Vilanterol</a:t>
            </a:r>
          </a:p>
          <a:p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lodaterol</a:t>
            </a:r>
            <a:endParaRPr lang="en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almeterol</a:t>
            </a: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ulobuterol patch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249234" y="1377141"/>
            <a:ext cx="383438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60774" y="3513537"/>
            <a:ext cx="1638525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Ultibro</a:t>
            </a:r>
            <a:r>
              <a:rPr lang="en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 Ind)</a:t>
            </a:r>
          </a:p>
          <a:p>
            <a:r>
              <a:rPr kumimoji="1"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noro</a:t>
            </a:r>
            <a:r>
              <a:rPr kumimoji="1" lang="en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kumimoji="1"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Ume/ </a:t>
            </a:r>
            <a:r>
              <a:rPr kumimoji="1"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r>
              <a:rPr kumimoji="1"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piolto</a:t>
            </a:r>
            <a:r>
              <a:rPr lang="en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Tio/ </a:t>
            </a:r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912261" y="3513537"/>
            <a:ext cx="38343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6395383" y="1390235"/>
            <a:ext cx="1178528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iclesonide</a:t>
            </a:r>
            <a:endParaRPr lang="en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luticasone</a:t>
            </a: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propionate</a:t>
            </a:r>
          </a:p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udesonide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535117" y="1377141"/>
            <a:ext cx="383438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8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138490" y="3513537"/>
            <a:ext cx="202972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ymbicort</a:t>
            </a:r>
            <a:r>
              <a:rPr lang="en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BUD/ For)</a:t>
            </a:r>
          </a:p>
          <a:p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Flutiform</a:t>
            </a:r>
            <a:r>
              <a:rPr lang="en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FP/ For)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944825" y="3513537"/>
            <a:ext cx="3834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3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053336" y="969005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AM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234994" y="969005"/>
            <a:ext cx="644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AB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861709" y="969005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C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54671" y="3094405"/>
            <a:ext cx="2237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AMA/ LABA combinatio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207397" y="3094405"/>
            <a:ext cx="2048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CS/ LABA combinatio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876411" y="3518107"/>
            <a:ext cx="51328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PI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MI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DI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6335384" y="3518106"/>
            <a:ext cx="383438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7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859458" y="3094405"/>
            <a:ext cx="25715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evice formulati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er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/>
          <p:cNvCxnSpPr/>
          <p:nvPr/>
        </p:nvCxnSpPr>
        <p:spPr>
          <a:xfrm flipV="1">
            <a:off x="321926" y="908667"/>
            <a:ext cx="84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/>
          <p:cNvCxnSpPr/>
          <p:nvPr/>
        </p:nvCxnSpPr>
        <p:spPr>
          <a:xfrm flipV="1">
            <a:off x="322161" y="1325497"/>
            <a:ext cx="84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/>
          <p:nvPr/>
        </p:nvCxnSpPr>
        <p:spPr>
          <a:xfrm flipV="1">
            <a:off x="333215" y="3029741"/>
            <a:ext cx="84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 flipV="1">
            <a:off x="322161" y="3471971"/>
            <a:ext cx="84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 flipV="1">
            <a:off x="322161" y="5068084"/>
            <a:ext cx="84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 flipV="1">
            <a:off x="333215" y="4504616"/>
            <a:ext cx="84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 flipV="1">
            <a:off x="322161" y="5759197"/>
            <a:ext cx="846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395895" y="511272"/>
            <a:ext cx="3637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. Previous inhaled medications (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ntroller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95895" y="4668778"/>
            <a:ext cx="1745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. Other treatment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57288" y="5180931"/>
            <a:ext cx="11993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heophylline</a:t>
            </a:r>
          </a:p>
          <a:p>
            <a:r>
              <a:rPr kumimoji="1"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ucolytic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850203" y="5180931"/>
            <a:ext cx="3834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222741" y="5180931"/>
            <a:ext cx="1447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xygen therap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656959" y="518093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1F8A291-EDBF-964C-9671-631B1CE70B94}"/>
              </a:ext>
            </a:extLst>
          </p:cNvPr>
          <p:cNvSpPr txBox="1"/>
          <p:nvPr/>
        </p:nvSpPr>
        <p:spPr>
          <a:xfrm>
            <a:off x="7140642" y="3525865"/>
            <a:ext cx="95410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PI+MDI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MI+DPI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MI+MDI</a:t>
            </a:r>
          </a:p>
          <a:p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32E5BC0-780D-CE47-8FF3-F267424C595C}"/>
              </a:ext>
            </a:extLst>
          </p:cNvPr>
          <p:cNvSpPr txBox="1"/>
          <p:nvPr/>
        </p:nvSpPr>
        <p:spPr>
          <a:xfrm>
            <a:off x="8038620" y="3513537"/>
            <a:ext cx="383438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8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4</a:t>
            </a:r>
          </a:p>
          <a:p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96FCABD-929D-474C-A082-F6C47A979FFA}"/>
              </a:ext>
            </a:extLst>
          </p:cNvPr>
          <p:cNvSpPr txBox="1"/>
          <p:nvPr/>
        </p:nvSpPr>
        <p:spPr>
          <a:xfrm>
            <a:off x="285516" y="185540"/>
            <a:ext cx="51568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Treatments used prior to this study  </a:t>
            </a:r>
            <a:endParaRPr kumimoji="1" lang="ja-JP" altLang="en-US" sz="14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FD01D35-5081-4341-B9DC-9BAF8485E740}"/>
              </a:ext>
            </a:extLst>
          </p:cNvPr>
          <p:cNvSpPr txBox="1"/>
          <p:nvPr/>
        </p:nvSpPr>
        <p:spPr>
          <a:xfrm>
            <a:off x="382457" y="5762249"/>
            <a:ext cx="863245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bbreviations: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LAMA, long-acting muscarinic antagonist; LABA, long-acting β2 agonist; ICS, Inhaled corticosteroid;</a:t>
            </a:r>
            <a:r>
              <a:rPr lang="ja-JP" altLang="ja-JP" sz="14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MI, soft mist inhaler;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lycopyrronium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; Ind, indacaterol; Ume, umeclidinium; </a:t>
            </a:r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vilanterol; Tio, tiotropium; </a:t>
            </a:r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lodaterol</a:t>
            </a:r>
            <a:r>
              <a:rPr lang="en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; BUD, budesonide; For, formoterol; FP, fluticasone propionate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; DPI, dry powder inhaler; MDI, metered dose inhaler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21663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DCCC7DA-910D-5D41-B58B-4573532BF489}"/>
              </a:ext>
            </a:extLst>
          </p:cNvPr>
          <p:cNvSpPr txBox="1"/>
          <p:nvPr/>
        </p:nvSpPr>
        <p:spPr>
          <a:xfrm>
            <a:off x="857161" y="1576147"/>
            <a:ext cx="1268296" cy="1338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5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20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5-R20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X5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Fre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Hz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LX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CDA6279-AE85-474F-8B11-B59B075FFC56}"/>
              </a:ext>
            </a:extLst>
          </p:cNvPr>
          <p:cNvSpPr txBox="1"/>
          <p:nvPr/>
        </p:nvSpPr>
        <p:spPr>
          <a:xfrm>
            <a:off x="2585019" y="1577487"/>
            <a:ext cx="941284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.9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± 1.50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88 ± 1.06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.06 ± 0.55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1.62 ± 1.76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4.04 ± 6.23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2.12 ± 16.64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0D8566B-C753-BE4B-B122-57B951D53D0A}"/>
              </a:ext>
            </a:extLst>
          </p:cNvPr>
          <p:cNvSpPr txBox="1"/>
          <p:nvPr/>
        </p:nvSpPr>
        <p:spPr>
          <a:xfrm>
            <a:off x="3640244" y="1576795"/>
            <a:ext cx="941284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.89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.38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9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96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8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53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1.64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.73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4.07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6.17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2.08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5.81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DA41721-9447-CE44-82E9-AAF0C2A14918}"/>
              </a:ext>
            </a:extLst>
          </p:cNvPr>
          <p:cNvSpPr txBox="1"/>
          <p:nvPr/>
        </p:nvSpPr>
        <p:spPr>
          <a:xfrm>
            <a:off x="4684301" y="1577488"/>
            <a:ext cx="941284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.76 ± 1.43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75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94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.0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60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.74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2.02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4.11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6.39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3.46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9.53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44B3940-E2AC-AB48-8D88-D1BA63136138}"/>
              </a:ext>
            </a:extLst>
          </p:cNvPr>
          <p:cNvSpPr txBox="1"/>
          <p:nvPr/>
        </p:nvSpPr>
        <p:spPr>
          <a:xfrm>
            <a:off x="5929584" y="1579126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753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869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902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93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94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99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25A60CD-C0BF-5B44-85A2-65913F364C36}"/>
              </a:ext>
            </a:extLst>
          </p:cNvPr>
          <p:cNvSpPr txBox="1"/>
          <p:nvPr/>
        </p:nvSpPr>
        <p:spPr>
          <a:xfrm>
            <a:off x="6768208" y="1579126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7339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7320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202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227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70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909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D6E25AA-3B15-054E-A8C5-23A38853620C}"/>
              </a:ext>
            </a:extLst>
          </p:cNvPr>
          <p:cNvSpPr txBox="1"/>
          <p:nvPr/>
        </p:nvSpPr>
        <p:spPr>
          <a:xfrm>
            <a:off x="7574347" y="1579126"/>
            <a:ext cx="540533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531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359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734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362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90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844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DE5A3F5-CC80-2346-9810-7EC50C7300FA}"/>
              </a:ext>
            </a:extLst>
          </p:cNvPr>
          <p:cNvSpPr txBox="1"/>
          <p:nvPr/>
        </p:nvSpPr>
        <p:spPr>
          <a:xfrm>
            <a:off x="590044" y="1435498"/>
            <a:ext cx="10438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xpiration phas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966BBF0-040D-634A-B16A-1E5B3028B189}"/>
              </a:ext>
            </a:extLst>
          </p:cNvPr>
          <p:cNvSpPr txBox="1"/>
          <p:nvPr/>
        </p:nvSpPr>
        <p:spPr>
          <a:xfrm>
            <a:off x="824753" y="3051321"/>
            <a:ext cx="1268296" cy="1338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5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20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5-R20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X5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Fre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Hz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LX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203CD5F-82DF-6A4D-9B89-27486C5E9E81}"/>
              </a:ext>
            </a:extLst>
          </p:cNvPr>
          <p:cNvSpPr txBox="1"/>
          <p:nvPr/>
        </p:nvSpPr>
        <p:spPr>
          <a:xfrm>
            <a:off x="2618943" y="3064771"/>
            <a:ext cx="877163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77 ±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8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28 ± 0.71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49 ± 0.46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0.88 ± 0.59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1.47 ± 3.97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.88 ± 4.66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337D151-9448-5745-B458-4CEBE4F220C9}"/>
              </a:ext>
            </a:extLst>
          </p:cNvPr>
          <p:cNvSpPr txBox="1"/>
          <p:nvPr/>
        </p:nvSpPr>
        <p:spPr>
          <a:xfrm>
            <a:off x="3708371" y="3064251"/>
            <a:ext cx="877163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.88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93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39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80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49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40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7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59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1.28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4.13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.79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4.70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14EAF57-71E8-AF4A-BD28-9D5E6E37EBCC}"/>
              </a:ext>
            </a:extLst>
          </p:cNvPr>
          <p:cNvSpPr txBox="1"/>
          <p:nvPr/>
        </p:nvSpPr>
        <p:spPr>
          <a:xfrm>
            <a:off x="4752428" y="3053655"/>
            <a:ext cx="877163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84 ± 1.04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28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74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55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47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0.90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69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1.59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4.57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.31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6.17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34D9577-70E2-784C-B78C-41ED083BA678}"/>
              </a:ext>
            </a:extLst>
          </p:cNvPr>
          <p:cNvSpPr txBox="1"/>
          <p:nvPr/>
        </p:nvSpPr>
        <p:spPr>
          <a:xfrm>
            <a:off x="5965650" y="3044004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7881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444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47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813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610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46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C9CCE33-E61B-DB40-920E-B6A943BA7A35}"/>
              </a:ext>
            </a:extLst>
          </p:cNvPr>
          <p:cNvSpPr txBox="1"/>
          <p:nvPr/>
        </p:nvSpPr>
        <p:spPr>
          <a:xfrm>
            <a:off x="6804274" y="3044004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113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85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7070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11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834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765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F19D718-4E21-214A-8CE0-562205C076B9}"/>
              </a:ext>
            </a:extLst>
          </p:cNvPr>
          <p:cNvSpPr txBox="1"/>
          <p:nvPr/>
        </p:nvSpPr>
        <p:spPr>
          <a:xfrm>
            <a:off x="7610413" y="3044004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669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774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456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477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976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267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A8163E9-8C58-E949-9D12-6BE2D701862E}"/>
              </a:ext>
            </a:extLst>
          </p:cNvPr>
          <p:cNvSpPr txBox="1"/>
          <p:nvPr/>
        </p:nvSpPr>
        <p:spPr>
          <a:xfrm>
            <a:off x="592167" y="2903347"/>
            <a:ext cx="10631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spiration phas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64436CD-B6E0-2947-8D3E-F5B3F15A5338}"/>
              </a:ext>
            </a:extLst>
          </p:cNvPr>
          <p:cNvSpPr txBox="1"/>
          <p:nvPr/>
        </p:nvSpPr>
        <p:spPr>
          <a:xfrm>
            <a:off x="857161" y="4555475"/>
            <a:ext cx="1268296" cy="1338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5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20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5-R20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X5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/s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Fre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Hz)</a:t>
            </a:r>
          </a:p>
          <a:p>
            <a:pPr font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LX (cmH</a:t>
            </a:r>
            <a:r>
              <a:rPr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/L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26DD49A-9020-F648-9E05-536EDB964CF5}"/>
              </a:ext>
            </a:extLst>
          </p:cNvPr>
          <p:cNvSpPr txBox="1"/>
          <p:nvPr/>
        </p:nvSpPr>
        <p:spPr>
          <a:xfrm>
            <a:off x="2582877" y="4557753"/>
            <a:ext cx="877163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.17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± 1.07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0 ± 0.59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57 ± 0.58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0.74 ± 1.36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56 ± 3.72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.24 ± 13.52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A52993C-D4AA-B847-A956-A6897D6780CD}"/>
              </a:ext>
            </a:extLst>
          </p:cNvPr>
          <p:cNvSpPr txBox="1"/>
          <p:nvPr/>
        </p:nvSpPr>
        <p:spPr>
          <a:xfrm>
            <a:off x="3672305" y="4557233"/>
            <a:ext cx="877163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.01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80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5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52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5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50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77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.34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.79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3.85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.28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2.71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EE64D39-A823-B446-93DB-2FF722FB9DE7}"/>
              </a:ext>
            </a:extLst>
          </p:cNvPr>
          <p:cNvSpPr txBox="1"/>
          <p:nvPr/>
        </p:nvSpPr>
        <p:spPr>
          <a:xfrm>
            <a:off x="4716362" y="4557926"/>
            <a:ext cx="877163" cy="13118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2 ± 0.75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47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48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45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0.39</a:t>
            </a:r>
          </a:p>
          <a:p>
            <a:pPr algn="ctr"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0.84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.52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.5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3.44</a:t>
            </a:r>
          </a:p>
          <a:p>
            <a:pPr algn="ctr"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.15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± 15.00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F0EBB45-17C2-974D-A035-AAAFA90F4F5D}"/>
              </a:ext>
            </a:extLst>
          </p:cNvPr>
          <p:cNvSpPr txBox="1"/>
          <p:nvPr/>
        </p:nvSpPr>
        <p:spPr>
          <a:xfrm>
            <a:off x="5929584" y="4559564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5429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5948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6788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08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294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98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4C5DC1E-F8E1-8D43-B504-029AC9437B64}"/>
              </a:ext>
            </a:extLst>
          </p:cNvPr>
          <p:cNvSpPr txBox="1"/>
          <p:nvPr/>
        </p:nvSpPr>
        <p:spPr>
          <a:xfrm>
            <a:off x="6768208" y="4559564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2216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3073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3468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978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969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185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A9D3DB3-C238-534C-AB9C-DB96082F4EA8}"/>
              </a:ext>
            </a:extLst>
          </p:cNvPr>
          <p:cNvSpPr txBox="1"/>
          <p:nvPr/>
        </p:nvSpPr>
        <p:spPr>
          <a:xfrm>
            <a:off x="7574347" y="4559564"/>
            <a:ext cx="537327" cy="1313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157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726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453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474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8990</a:t>
            </a:r>
          </a:p>
          <a:p>
            <a:pPr>
              <a:lnSpc>
                <a:spcPct val="1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0.9260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3E20B54-E472-0D45-9DEC-B6407DA398FE}"/>
              </a:ext>
            </a:extLst>
          </p:cNvPr>
          <p:cNvSpPr txBox="1"/>
          <p:nvPr/>
        </p:nvSpPr>
        <p:spPr>
          <a:xfrm>
            <a:off x="596562" y="4384608"/>
            <a:ext cx="20223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ΔExpiration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minus Inspiration phas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6F8BFD6-CE7D-AC4B-BDBD-77A9D0DDE298}"/>
              </a:ext>
            </a:extLst>
          </p:cNvPr>
          <p:cNvSpPr txBox="1"/>
          <p:nvPr/>
        </p:nvSpPr>
        <p:spPr>
          <a:xfrm>
            <a:off x="5806627" y="1050248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/ Ind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Ume/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AF509CE-CA0A-3949-9B59-FFBDD425E50A}"/>
              </a:ext>
            </a:extLst>
          </p:cNvPr>
          <p:cNvSpPr txBox="1"/>
          <p:nvPr/>
        </p:nvSpPr>
        <p:spPr>
          <a:xfrm>
            <a:off x="6661465" y="105024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/ Ind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Tio/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B0961CA-7DFF-A14A-8DCA-07C960B76422}"/>
              </a:ext>
            </a:extLst>
          </p:cNvPr>
          <p:cNvSpPr txBox="1"/>
          <p:nvPr/>
        </p:nvSpPr>
        <p:spPr>
          <a:xfrm>
            <a:off x="7472780" y="105024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me/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Tio/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280B548-DE96-2949-A002-2F7619B6D297}"/>
              </a:ext>
            </a:extLst>
          </p:cNvPr>
          <p:cNvSpPr txBox="1"/>
          <p:nvPr/>
        </p:nvSpPr>
        <p:spPr>
          <a:xfrm>
            <a:off x="6777191" y="839844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valu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D065BB9-0D8E-7E44-80E5-1FF66163ABFA}"/>
              </a:ext>
            </a:extLst>
          </p:cNvPr>
          <p:cNvSpPr txBox="1"/>
          <p:nvPr/>
        </p:nvSpPr>
        <p:spPr>
          <a:xfrm>
            <a:off x="2736030" y="1066043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/ Ind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8F62CF4-7A93-7E48-AB3F-55AA24A2DD75}"/>
              </a:ext>
            </a:extLst>
          </p:cNvPr>
          <p:cNvSpPr txBox="1"/>
          <p:nvPr/>
        </p:nvSpPr>
        <p:spPr>
          <a:xfrm>
            <a:off x="4832765" y="1043586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io/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73863DE-452F-3C43-833F-DCB7F2B49558}"/>
              </a:ext>
            </a:extLst>
          </p:cNvPr>
          <p:cNvSpPr txBox="1"/>
          <p:nvPr/>
        </p:nvSpPr>
        <p:spPr>
          <a:xfrm>
            <a:off x="3761654" y="1059952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me/ </a:t>
            </a:r>
            <a:r>
              <a:rPr kumimoji="1"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53A07A00-F13C-054C-8E4C-E44687855AB4}"/>
              </a:ext>
            </a:extLst>
          </p:cNvPr>
          <p:cNvCxnSpPr>
            <a:cxnSpLocks/>
          </p:cNvCxnSpPr>
          <p:nvPr/>
        </p:nvCxnSpPr>
        <p:spPr>
          <a:xfrm>
            <a:off x="5795338" y="1064280"/>
            <a:ext cx="2472508" cy="13704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705F7E21-E431-0240-A192-41FCF9F30F85}"/>
              </a:ext>
            </a:extLst>
          </p:cNvPr>
          <p:cNvCxnSpPr/>
          <p:nvPr/>
        </p:nvCxnSpPr>
        <p:spPr>
          <a:xfrm>
            <a:off x="474052" y="1435498"/>
            <a:ext cx="792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4938D3EC-68FB-EE4B-9813-E4E93CCDCB03}"/>
              </a:ext>
            </a:extLst>
          </p:cNvPr>
          <p:cNvCxnSpPr/>
          <p:nvPr/>
        </p:nvCxnSpPr>
        <p:spPr>
          <a:xfrm>
            <a:off x="474052" y="5907815"/>
            <a:ext cx="792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6494F5D5-06DB-D345-AC0D-374DCDC72B04}"/>
              </a:ext>
            </a:extLst>
          </p:cNvPr>
          <p:cNvCxnSpPr/>
          <p:nvPr/>
        </p:nvCxnSpPr>
        <p:spPr>
          <a:xfrm>
            <a:off x="511682" y="824716"/>
            <a:ext cx="792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E797A26-988A-184F-8250-6FB49849132C}"/>
              </a:ext>
            </a:extLst>
          </p:cNvPr>
          <p:cNvSpPr/>
          <p:nvPr/>
        </p:nvSpPr>
        <p:spPr>
          <a:xfrm>
            <a:off x="496459" y="332277"/>
            <a:ext cx="795763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3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Forced oscillation technique (FOT)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t expiration phase, inspiration phase, and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ΔExpiration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minus inspiration phase using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ostGraph-01® after each inhaler use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AF7B6AE-6B16-A740-B0FA-867FE1D06D2C}"/>
              </a:ext>
            </a:extLst>
          </p:cNvPr>
          <p:cNvSpPr txBox="1"/>
          <p:nvPr/>
        </p:nvSpPr>
        <p:spPr>
          <a:xfrm>
            <a:off x="474052" y="5974254"/>
            <a:ext cx="7957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900" b="1" dirty="0">
                <a:latin typeface="Arial" panose="020B0604020202020204" pitchFamily="34" charset="0"/>
                <a:cs typeface="Arial" panose="020B0604020202020204" pitchFamily="34" charset="0"/>
              </a:rPr>
              <a:t>Abbreviations:</a:t>
            </a:r>
            <a:r>
              <a:rPr lang="en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, difference between the inspiratory and expiratory phases; R5, resistance of respiratory system at 5Hz; R20, resistance of respiratory system at 20Hz; X5, reactance of respiratory system at 5Hz;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Fre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, resonant frequency; ALX, low-frequency reactance area</a:t>
            </a:r>
            <a:endParaRPr lang="ja-JP" altLang="ja-JP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95929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5E0D8E-2E35-B241-885A-1DBF872EC75C}"/>
              </a:ext>
            </a:extLst>
          </p:cNvPr>
          <p:cNvSpPr txBox="1"/>
          <p:nvPr/>
        </p:nvSpPr>
        <p:spPr>
          <a:xfrm>
            <a:off x="447754" y="1382786"/>
            <a:ext cx="4143737" cy="50013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easons for selecting </a:t>
            </a:r>
            <a:r>
              <a:rPr lang="en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/ Ind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Good actual feeling of being able to inhale due to transparent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 capsule (confirmed by eye) or sound during inhalation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                       ..... 16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Good effect ..... 7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Operability ..... 3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I'm used to ..... 2 people</a:t>
            </a:r>
          </a:p>
          <a:p>
            <a:endParaRPr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isadvantages for </a:t>
            </a:r>
            <a:r>
              <a:rPr lang="en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/ Ind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DPI is powdery ..... 2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Troublesome ….. 1 person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Choked on more than Ume/ </a:t>
            </a:r>
            <a:r>
              <a:rPr lang="en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….. 1 person</a:t>
            </a:r>
          </a:p>
          <a:p>
            <a:endParaRPr kumimoji="1"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easons for selecting Ume/ </a:t>
            </a:r>
            <a:r>
              <a:rPr lang="en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Easy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perability ….. 10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Good actual feeling of being able to inhale ….. 3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Good effect ..... 3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ood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eeling in my mouth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Sweet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With counter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</a:p>
          <a:p>
            <a:endParaRPr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isadvantages for Ume/ </a:t>
            </a:r>
            <a:r>
              <a:rPr lang="en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endParaRPr lang="en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DPI is powdery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2 people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No feeling of inhalation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Larger siz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Mouth does not fit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Sweet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  <a:b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No effect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 person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36A700C-C48E-C143-97C7-4D946635D74B}"/>
              </a:ext>
            </a:extLst>
          </p:cNvPr>
          <p:cNvSpPr txBox="1"/>
          <p:nvPr/>
        </p:nvSpPr>
        <p:spPr>
          <a:xfrm>
            <a:off x="447754" y="861059"/>
            <a:ext cx="170751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espondents: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57          </a:t>
            </a:r>
          </a:p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Non-respondents: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47C2D6E-C845-774C-80B6-B8699F4FCB39}"/>
              </a:ext>
            </a:extLst>
          </p:cNvPr>
          <p:cNvSpPr txBox="1"/>
          <p:nvPr/>
        </p:nvSpPr>
        <p:spPr>
          <a:xfrm>
            <a:off x="4730046" y="1382786"/>
            <a:ext cx="3589865" cy="3308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Reasons for selecting Tio/ </a:t>
            </a:r>
            <a:r>
              <a:rPr lang="en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lo</a:t>
            </a:r>
            <a:endParaRPr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Good effect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Good actual feeling of being able to inha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          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Operability (Easy when getting used to) ….. 3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Slowly can inhale ….. 2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I'm used to ….. 2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No irritation, no coughing ….. 2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Tasteless / not sweet ….. 2 people</a:t>
            </a:r>
          </a:p>
          <a:p>
            <a:endParaRPr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Disadvantages for Tio/ </a:t>
            </a:r>
            <a:r>
              <a:rPr lang="en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endParaRPr lang="en" altLang="ja-JP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Choked on ….. 2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No feeling of being able to inhale ….. 2 people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Difficult to throw away ….. 1 person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Strong thirst ….. 1 person</a:t>
            </a:r>
          </a:p>
          <a:p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•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 failure of inhaling at times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….. 1 person</a:t>
            </a:r>
          </a:p>
          <a:p>
            <a:endParaRPr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All equivalent </a:t>
            </a:r>
            <a:r>
              <a:rPr lang="en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….. 1 person</a:t>
            </a:r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86BAB52-EF14-FA4E-B819-7438439CC868}"/>
              </a:ext>
            </a:extLst>
          </p:cNvPr>
          <p:cNvSpPr txBox="1"/>
          <p:nvPr/>
        </p:nvSpPr>
        <p:spPr>
          <a:xfrm>
            <a:off x="412772" y="335345"/>
            <a:ext cx="48460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4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easons for selectio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in free comments)</a:t>
            </a:r>
            <a:endParaRPr lang="en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042DEC7D-9E76-7F46-8902-1BFA94C88BEB}"/>
              </a:ext>
            </a:extLst>
          </p:cNvPr>
          <p:cNvCxnSpPr/>
          <p:nvPr/>
        </p:nvCxnSpPr>
        <p:spPr>
          <a:xfrm>
            <a:off x="323703" y="794690"/>
            <a:ext cx="810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82331316-D664-6147-8078-B8CD884C0E0C}"/>
              </a:ext>
            </a:extLst>
          </p:cNvPr>
          <p:cNvCxnSpPr/>
          <p:nvPr/>
        </p:nvCxnSpPr>
        <p:spPr>
          <a:xfrm>
            <a:off x="323703" y="6250846"/>
            <a:ext cx="8100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804193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F05FCEF-4F58-354B-ABA1-8DE285BC6136}"/>
              </a:ext>
            </a:extLst>
          </p:cNvPr>
          <p:cNvSpPr txBox="1"/>
          <p:nvPr/>
        </p:nvSpPr>
        <p:spPr>
          <a:xfrm>
            <a:off x="551825" y="960796"/>
            <a:ext cx="1225015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ex    Male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Female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Age (years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eight (cm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Body weight (Kg)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I (Kg/m</a:t>
            </a:r>
            <a:r>
              <a:rPr lang="en-US" altLang="ja-JP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Smoking (pack year)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IF; free (L/min) 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IF; H/H (L/min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IC (L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FVC (L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%FVC (%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FEV1 (L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%FEV1 (%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FEV1/FVC (%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MF (L/s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F (L/s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V50 (L/s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V25 (L/s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V50/V25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Post BD-FEV1 (L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%PostBD-FEV1 (%)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Asthma +/- (%)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ontroller device(1)*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Controller device(2)**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DPI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  BH®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  Ellipta®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MDI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SMI (Respimat®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LAMA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Ume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Tio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 -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LABA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Ind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For(DPI)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For(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MDI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-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ICS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+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            -</a:t>
            </a:r>
          </a:p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First medication preceded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/Ind, Ume/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, Tio/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DF1CB51-1989-DE4E-B1B3-FF7BF9B7B6A3}"/>
              </a:ext>
            </a:extLst>
          </p:cNvPr>
          <p:cNvSpPr txBox="1"/>
          <p:nvPr/>
        </p:nvSpPr>
        <p:spPr>
          <a:xfrm>
            <a:off x="1713980" y="469660"/>
            <a:ext cx="8739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Chosing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/ Ind 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as the first rank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42BD346-3F5A-9447-97C9-B74CD514C8AE}"/>
              </a:ext>
            </a:extLst>
          </p:cNvPr>
          <p:cNvSpPr txBox="1"/>
          <p:nvPr/>
        </p:nvSpPr>
        <p:spPr>
          <a:xfrm>
            <a:off x="1815723" y="960796"/>
            <a:ext cx="724878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3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78.1 ± 6.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64.7 ± 7.8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9.3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10.6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1.9 ± 3.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6.1 ± 33.7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96.4 ± 58.1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2.6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6.7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81 ± 0.53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.64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0.70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81.8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15.4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31 ± 0.5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2.8 ± 21.0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9.6 ± 14.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52 ± 0.3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.31 ± 1.90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66 ± 0.4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25 ± 0.1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.63 ± 1.1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35 ± 0.5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2.8 ± 21.0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/27 (12.9)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0, 11, 10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3F58EA1-B30D-564A-B6D2-0AE878EB8D51}"/>
              </a:ext>
            </a:extLst>
          </p:cNvPr>
          <p:cNvSpPr txBox="1"/>
          <p:nvPr/>
        </p:nvSpPr>
        <p:spPr>
          <a:xfrm>
            <a:off x="2634687" y="960795"/>
            <a:ext cx="724878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79.4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6.5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63.4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7.2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9.2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11.6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2.1 ± 3.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61.8 ± 39.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90.0 ± 53.7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1.8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6.5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84 ± 0.62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.66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0.82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83.87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17.7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41 ± 0.6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6.9 ± 20.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2.2 ± 13.1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56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0.34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.58 ± 2.13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3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0.50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25 ± 0.12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.83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1.25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46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0.64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6.9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20.3</a:t>
            </a:r>
          </a:p>
          <a:p>
            <a:pPr algn="ctr"/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/17 (15.0)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9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0  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pPr algn="ctr"/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7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7,  7,  6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B44DF9-3B9E-2F4C-847E-EEB1B568F50D}"/>
              </a:ext>
            </a:extLst>
          </p:cNvPr>
          <p:cNvSpPr txBox="1"/>
          <p:nvPr/>
        </p:nvSpPr>
        <p:spPr>
          <a:xfrm>
            <a:off x="3388492" y="960796"/>
            <a:ext cx="891932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79.3 ± 6.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63.9 ±  7.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9.3 ± 10.7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2.0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3.6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6.7 ± 33.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99.8 ± 58.3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2.8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6.5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79 ± 0.53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.60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0.68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81.6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15.4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33 ± 0.5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4.9 ± 21.5</a:t>
            </a:r>
          </a:p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1.4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± 14.3</a:t>
            </a:r>
            <a:endParaRPr kumimoji="1"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55 ± 0.3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.38 ± 1.8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69 ± 0.4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26 ± 0.1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.67 ± 1.0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38 ± 0.5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4.9 ± 21.5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/27 (10.0)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9  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3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 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9, 10, 11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7F40C37-A4D1-3747-9CDA-2BEDEF24C489}"/>
              </a:ext>
            </a:extLst>
          </p:cNvPr>
          <p:cNvSpPr txBox="1"/>
          <p:nvPr/>
        </p:nvSpPr>
        <p:spPr>
          <a:xfrm>
            <a:off x="5052847" y="588067"/>
            <a:ext cx="662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/ Ind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vs. 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Ume/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F5F3DB6-E3D6-724C-9DA6-E622A7E1A208}"/>
              </a:ext>
            </a:extLst>
          </p:cNvPr>
          <p:cNvSpPr txBox="1"/>
          <p:nvPr/>
        </p:nvSpPr>
        <p:spPr>
          <a:xfrm>
            <a:off x="5659002" y="586337"/>
            <a:ext cx="662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Gly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/ Ind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vs. 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Tio/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7FFBF20-DBDA-8545-B515-08C0AF40C89D}"/>
              </a:ext>
            </a:extLst>
          </p:cNvPr>
          <p:cNvSpPr txBox="1"/>
          <p:nvPr/>
        </p:nvSpPr>
        <p:spPr>
          <a:xfrm>
            <a:off x="6263555" y="584607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Ume/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vs.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Tio/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C881BF4-A5FB-874F-B9D0-9B9CD64F525E}"/>
              </a:ext>
            </a:extLst>
          </p:cNvPr>
          <p:cNvSpPr txBox="1"/>
          <p:nvPr/>
        </p:nvSpPr>
        <p:spPr>
          <a:xfrm>
            <a:off x="5060003" y="960796"/>
            <a:ext cx="532688" cy="5155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85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21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8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61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37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17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82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85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76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92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35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79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910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26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76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73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9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10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11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532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9DBCF52-2CAC-8343-838F-65738B6AC90F}"/>
              </a:ext>
            </a:extLst>
          </p:cNvPr>
          <p:cNvSpPr txBox="1"/>
          <p:nvPr/>
        </p:nvSpPr>
        <p:spPr>
          <a:xfrm>
            <a:off x="2541462" y="470239"/>
            <a:ext cx="901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Chosing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Ume/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Vil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as the first rank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3C9208D-8D34-634E-AF5D-A4C4944A132A}"/>
              </a:ext>
            </a:extLst>
          </p:cNvPr>
          <p:cNvSpPr txBox="1"/>
          <p:nvPr/>
        </p:nvSpPr>
        <p:spPr>
          <a:xfrm>
            <a:off x="3389673" y="462333"/>
            <a:ext cx="8771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Chosing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Tio/ </a:t>
            </a:r>
            <a:r>
              <a:rPr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Olo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as the first rank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F487D2BD-7C64-A846-A8AC-940E6FFC447D}"/>
              </a:ext>
            </a:extLst>
          </p:cNvPr>
          <p:cNvCxnSpPr>
            <a:cxnSpLocks/>
          </p:cNvCxnSpPr>
          <p:nvPr/>
        </p:nvCxnSpPr>
        <p:spPr>
          <a:xfrm>
            <a:off x="511030" y="923213"/>
            <a:ext cx="644400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D59D1304-C4C9-5849-81B6-DBB69E1A23E4}"/>
              </a:ext>
            </a:extLst>
          </p:cNvPr>
          <p:cNvCxnSpPr>
            <a:cxnSpLocks/>
          </p:cNvCxnSpPr>
          <p:nvPr/>
        </p:nvCxnSpPr>
        <p:spPr>
          <a:xfrm>
            <a:off x="4987049" y="604717"/>
            <a:ext cx="187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1F3A235-996C-D74E-A13E-C65A2CEADB85}"/>
              </a:ext>
            </a:extLst>
          </p:cNvPr>
          <p:cNvSpPr txBox="1"/>
          <p:nvPr/>
        </p:nvSpPr>
        <p:spPr>
          <a:xfrm>
            <a:off x="4416775" y="407768"/>
            <a:ext cx="57027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ANOVA 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or χ</a:t>
            </a:r>
            <a:r>
              <a:rPr lang="en-US" altLang="ja-JP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test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value)</a:t>
            </a:r>
            <a:endParaRPr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83E294E-1A48-3546-95FB-0570BCE3B697}"/>
              </a:ext>
            </a:extLst>
          </p:cNvPr>
          <p:cNvSpPr txBox="1"/>
          <p:nvPr/>
        </p:nvSpPr>
        <p:spPr>
          <a:xfrm>
            <a:off x="5369511" y="391064"/>
            <a:ext cx="13638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Tukey’s HSD test (</a:t>
            </a:r>
            <a:r>
              <a:rPr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-value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4CAF60B-9722-214F-8A73-340441DBC3FE}"/>
              </a:ext>
            </a:extLst>
          </p:cNvPr>
          <p:cNvSpPr txBox="1"/>
          <p:nvPr/>
        </p:nvSpPr>
        <p:spPr>
          <a:xfrm>
            <a:off x="4468242" y="962792"/>
            <a:ext cx="812447" cy="52629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882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366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292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89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623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349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373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455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540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543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688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455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927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818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167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834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815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089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172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229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699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643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783</a:t>
            </a: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946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31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75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30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03</a:t>
            </a:r>
          </a:p>
          <a:p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6EB4CDD-3856-0D43-8FC9-C72F99057AEA}"/>
              </a:ext>
            </a:extLst>
          </p:cNvPr>
          <p:cNvSpPr txBox="1"/>
          <p:nvPr/>
        </p:nvSpPr>
        <p:spPr>
          <a:xfrm>
            <a:off x="5647113" y="963296"/>
            <a:ext cx="532688" cy="5155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784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23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9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80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7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23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44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49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53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8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85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19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62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41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0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53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42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89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82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303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7356F67-4551-CB40-BA65-0049C40DFB3B}"/>
              </a:ext>
            </a:extLst>
          </p:cNvPr>
          <p:cNvSpPr txBox="1"/>
          <p:nvPr/>
        </p:nvSpPr>
        <p:spPr>
          <a:xfrm>
            <a:off x="6270929" y="967501"/>
            <a:ext cx="532688" cy="5155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7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64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0000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4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714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71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5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85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3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752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057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443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806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6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275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709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130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758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8921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170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sz="7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F23AD193-6D71-E440-9840-43D2C019D361}"/>
              </a:ext>
            </a:extLst>
          </p:cNvPr>
          <p:cNvCxnSpPr>
            <a:cxnSpLocks/>
          </p:cNvCxnSpPr>
          <p:nvPr/>
        </p:nvCxnSpPr>
        <p:spPr>
          <a:xfrm>
            <a:off x="506787" y="374010"/>
            <a:ext cx="644400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B912DA05-E9B6-B346-841A-4BC100A91687}"/>
              </a:ext>
            </a:extLst>
          </p:cNvPr>
          <p:cNvCxnSpPr>
            <a:cxnSpLocks/>
          </p:cNvCxnSpPr>
          <p:nvPr/>
        </p:nvCxnSpPr>
        <p:spPr>
          <a:xfrm>
            <a:off x="504946" y="6251092"/>
            <a:ext cx="6444000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C6FFFE2D-2C0E-584D-B9BE-E8274269F814}"/>
              </a:ext>
            </a:extLst>
          </p:cNvPr>
          <p:cNvSpPr txBox="1"/>
          <p:nvPr/>
        </p:nvSpPr>
        <p:spPr>
          <a:xfrm>
            <a:off x="274315" y="77414"/>
            <a:ext cx="7587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5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 Relationship between the first-ranking LAMA/ LABA FDC and background factors of patients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5CF5674-522A-9644-99DB-EB4C419C8BB8}"/>
              </a:ext>
            </a:extLst>
          </p:cNvPr>
          <p:cNvSpPr txBox="1"/>
          <p:nvPr/>
        </p:nvSpPr>
        <p:spPr>
          <a:xfrm>
            <a:off x="540511" y="6260549"/>
            <a:ext cx="5681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/>
              <a:t>Notes:</a:t>
            </a:r>
            <a:r>
              <a:rPr lang="ja-JP" altLang="ja-JP" sz="800"/>
              <a:t>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 Controller device(1): the relationship between medications selected as the first rank and BH, Ellipta, or Respimat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** Controller device(2): the relationship between medications selected as the first rank and DPI or SMI</a:t>
            </a:r>
          </a:p>
        </p:txBody>
      </p:sp>
    </p:spTree>
    <p:extLst>
      <p:ext uri="{BB962C8B-B14F-4D97-AF65-F5344CB8AC3E}">
        <p14:creationId xmlns:p14="http://schemas.microsoft.com/office/powerpoint/2010/main" val="191919684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44</TotalTime>
  <Words>2334</Words>
  <Application>Microsoft Macintosh PowerPoint</Application>
  <PresentationFormat>画面に合わせる (4:3)</PresentationFormat>
  <Paragraphs>721</Paragraphs>
  <Slides>6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游ゴシック</vt:lpstr>
      <vt:lpstr>Arial</vt:lpstr>
      <vt:lpstr>Calibri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木 正人</dc:creator>
  <cp:lastModifiedBy>村木正人</cp:lastModifiedBy>
  <cp:revision>312</cp:revision>
  <dcterms:created xsi:type="dcterms:W3CDTF">2018-01-09T08:38:13Z</dcterms:created>
  <dcterms:modified xsi:type="dcterms:W3CDTF">2020-12-03T12:28:17Z</dcterms:modified>
</cp:coreProperties>
</file>